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0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1" t="36568" r="15286" b="35235"/>
          <a:stretch/>
        </p:blipFill>
        <p:spPr>
          <a:xfrm>
            <a:off x="684866" y="1628800"/>
            <a:ext cx="7609736" cy="236109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827584" y="476672"/>
            <a:ext cx="698477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Additional file 14: Sampling scheme for spoilage of RTE meals in absence/presence of food preservatives. </a:t>
            </a:r>
            <a:r>
              <a:rPr lang="en-US" sz="1200" dirty="0"/>
              <a:t>Each sample is indicated by a number. CFU counts were determined for each individual sample, whereas chromosomal DNA for 16S </a:t>
            </a:r>
            <a:r>
              <a:rPr lang="en-US" sz="1200" dirty="0" err="1"/>
              <a:t>rRNA</a:t>
            </a:r>
            <a:r>
              <a:rPr lang="en-US" sz="1200" dirty="0"/>
              <a:t> bar-coded </a:t>
            </a:r>
            <a:r>
              <a:rPr lang="en-US" sz="1200" dirty="0" err="1"/>
              <a:t>amplicon</a:t>
            </a:r>
            <a:r>
              <a:rPr lang="en-US" sz="1200" dirty="0"/>
              <a:t> sequencing was isolated from two aliquots of selected individual samples (indicated in bold) to serve as biological duplicates. Time is shown as number of days inoculation at 7</a:t>
            </a:r>
            <a:r>
              <a:rPr lang="en-US" sz="1200" dirty="0">
                <a:sym typeface="Symbol"/>
              </a:rPr>
              <a:t></a:t>
            </a:r>
            <a:r>
              <a:rPr lang="en-US" sz="1200" dirty="0"/>
              <a:t>C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1699987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7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12</cp:revision>
  <dcterms:created xsi:type="dcterms:W3CDTF">2015-05-01T20:53:39Z</dcterms:created>
  <dcterms:modified xsi:type="dcterms:W3CDTF">2015-05-01T21:25:33Z</dcterms:modified>
</cp:coreProperties>
</file>